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8" r:id="rId3"/>
    <p:sldId id="269" r:id="rId4"/>
    <p:sldId id="270" r:id="rId5"/>
    <p:sldId id="271" r:id="rId6"/>
    <p:sldId id="260" r:id="rId7"/>
    <p:sldId id="266" r:id="rId8"/>
  </p:sldIdLst>
  <p:sldSz cx="12192000" cy="6858000"/>
  <p:notesSz cx="6858000" cy="9144000"/>
  <p:defaultTextStyle>
    <a:defPPr>
      <a:defRPr lang="fa-I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990978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88052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822182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75930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154305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222344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644887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774112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19389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62549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329545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080E5-48DA-4AB3-89C4-A65B6746F6C7}" type="datetimeFigureOut">
              <a:rPr lang="fa-IR" smtClean="0"/>
              <a:t>03/04/1438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64794C-EF61-48DD-901B-34AABDD6D7C5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863153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 rot="16200000">
            <a:off x="-531376" y="1673023"/>
            <a:ext cx="141667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Coexpression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30" y="282912"/>
            <a:ext cx="4069723" cy="316819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7653" y="282911"/>
            <a:ext cx="4085128" cy="316820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483" y="282912"/>
            <a:ext cx="3761516" cy="3168200"/>
          </a:xfrm>
          <a:prstGeom prst="rect">
            <a:avLst/>
          </a:prstGeom>
        </p:spPr>
      </p:pic>
      <p:sp>
        <p:nvSpPr>
          <p:cNvPr id="13" name="TextBox 58"/>
          <p:cNvSpPr txBox="1"/>
          <p:nvPr/>
        </p:nvSpPr>
        <p:spPr>
          <a:xfrm>
            <a:off x="9126215" y="-6306"/>
            <a:ext cx="3065784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Neighborhood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Miscellanous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14" name="TextBox 57"/>
          <p:cNvSpPr txBox="1"/>
          <p:nvPr/>
        </p:nvSpPr>
        <p:spPr>
          <a:xfrm>
            <a:off x="1777794" y="-24865"/>
            <a:ext cx="1530639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istance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15" name="TextBox 59"/>
          <p:cNvSpPr txBox="1"/>
          <p:nvPr/>
        </p:nvSpPr>
        <p:spPr>
          <a:xfrm>
            <a:off x="5091383" y="-6306"/>
            <a:ext cx="2593075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egree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Eigen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7307" y="3451111"/>
            <a:ext cx="4150967" cy="3406889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16200000">
            <a:off x="-1127286" y="4878470"/>
            <a:ext cx="260849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Coexpression_transferred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95682" y="3451111"/>
            <a:ext cx="4011694" cy="340688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30483" y="3451111"/>
            <a:ext cx="3761516" cy="34068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44611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-523672" y="1518566"/>
            <a:ext cx="141667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smtClean="0">
                <a:latin typeface="Adobe Caslon Pro" panose="0205050205050A020403" pitchFamily="18" charset="0"/>
              </a:rPr>
              <a:t>Database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332" y="18377"/>
            <a:ext cx="3976023" cy="352975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5356" y="18376"/>
            <a:ext cx="4085128" cy="352975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483" y="0"/>
            <a:ext cx="3761518" cy="354813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-912233" y="5021050"/>
            <a:ext cx="2195482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Database_transferred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9331" y="3548132"/>
            <a:ext cx="3976024" cy="330986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5355" y="3548131"/>
            <a:ext cx="4085127" cy="331080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35771" y="3548130"/>
            <a:ext cx="3756229" cy="3313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4203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-523673" y="1518567"/>
            <a:ext cx="141667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smtClean="0">
                <a:latin typeface="Adobe Caslon Pro" panose="0205050205050A020403" pitchFamily="18" charset="0"/>
              </a:rPr>
              <a:t>Experiments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45354" y="0"/>
            <a:ext cx="4085127" cy="354813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9330" y="35031"/>
            <a:ext cx="3976021" cy="351310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482" y="33051"/>
            <a:ext cx="3761518" cy="351508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-1069185" y="5232591"/>
            <a:ext cx="2509382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Experiments_transferred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9330" y="3548133"/>
            <a:ext cx="4019533" cy="330986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88864" y="3548133"/>
            <a:ext cx="4041618" cy="330986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30481" y="3548132"/>
            <a:ext cx="3761519" cy="3309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6717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 rot="16200000">
            <a:off x="-737951" y="1523563"/>
            <a:ext cx="184523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Textmining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332" y="180304"/>
            <a:ext cx="3976025" cy="312956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5355" y="180303"/>
            <a:ext cx="4085129" cy="314803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484" y="180302"/>
            <a:ext cx="3761516" cy="3129566"/>
          </a:xfrm>
          <a:prstGeom prst="rect">
            <a:avLst/>
          </a:prstGeom>
        </p:spPr>
      </p:pic>
      <p:sp>
        <p:nvSpPr>
          <p:cNvPr id="14" name="TextBox 58"/>
          <p:cNvSpPr txBox="1"/>
          <p:nvPr/>
        </p:nvSpPr>
        <p:spPr>
          <a:xfrm>
            <a:off x="9126215" y="-6306"/>
            <a:ext cx="3065784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Neighborhood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Miscellanous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18" name="TextBox 57"/>
          <p:cNvSpPr txBox="1"/>
          <p:nvPr/>
        </p:nvSpPr>
        <p:spPr>
          <a:xfrm>
            <a:off x="1777794" y="-24865"/>
            <a:ext cx="1530639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istance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19" name="TextBox 59"/>
          <p:cNvSpPr txBox="1"/>
          <p:nvPr/>
        </p:nvSpPr>
        <p:spPr>
          <a:xfrm>
            <a:off x="5091383" y="-6306"/>
            <a:ext cx="2593075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egree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Eigen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9332" y="3328336"/>
            <a:ext cx="3976023" cy="3529664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 rot="16200000">
            <a:off x="-1168293" y="4908502"/>
            <a:ext cx="270591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Textmining_transferred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5354" y="3328334"/>
            <a:ext cx="4085129" cy="352966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30481" y="3309867"/>
            <a:ext cx="3761517" cy="35481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41697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-523672" y="4828434"/>
            <a:ext cx="141667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smtClean="0">
                <a:latin typeface="Adobe Caslon Pro" panose="0205050205050A020403" pitchFamily="18" charset="0"/>
              </a:rPr>
              <a:t>Fusion </a:t>
            </a:r>
            <a:endParaRPr lang="fa-IR" dirty="0">
              <a:latin typeface="Adobe Caslon Pro" panose="0205050205050A020403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-737951" y="1523563"/>
            <a:ext cx="184523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smtClean="0">
                <a:latin typeface="Adobe Caslon Pro" panose="0205050205050A020403" pitchFamily="18" charset="0"/>
              </a:rPr>
              <a:t>Homology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332" y="206062"/>
            <a:ext cx="3976025" cy="319581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5357" y="206060"/>
            <a:ext cx="4085127" cy="319581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484" y="206060"/>
            <a:ext cx="3761516" cy="3195813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9332" y="3401875"/>
            <a:ext cx="3976025" cy="345612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5357" y="3401875"/>
            <a:ext cx="4085127" cy="345612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30485" y="3401875"/>
            <a:ext cx="3761516" cy="3456125"/>
          </a:xfrm>
          <a:prstGeom prst="rect">
            <a:avLst/>
          </a:prstGeom>
        </p:spPr>
      </p:pic>
      <p:sp>
        <p:nvSpPr>
          <p:cNvPr id="16" name="TextBox 58"/>
          <p:cNvSpPr txBox="1"/>
          <p:nvPr/>
        </p:nvSpPr>
        <p:spPr>
          <a:xfrm>
            <a:off x="9126215" y="-6306"/>
            <a:ext cx="3065784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Neighborhood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Miscellanous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17" name="TextBox 57"/>
          <p:cNvSpPr txBox="1"/>
          <p:nvPr/>
        </p:nvSpPr>
        <p:spPr>
          <a:xfrm>
            <a:off x="1777794" y="-24865"/>
            <a:ext cx="1530639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istance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18" name="TextBox 59"/>
          <p:cNvSpPr txBox="1"/>
          <p:nvPr/>
        </p:nvSpPr>
        <p:spPr>
          <a:xfrm>
            <a:off x="5091383" y="-6306"/>
            <a:ext cx="2593075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egree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Eigen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07576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 rot="16200000">
            <a:off x="-737951" y="1523563"/>
            <a:ext cx="184523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Cooccurence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332" y="218941"/>
            <a:ext cx="3976026" cy="310930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5356" y="218941"/>
            <a:ext cx="4085128" cy="3109303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483" y="206062"/>
            <a:ext cx="3761517" cy="3103806"/>
          </a:xfrm>
          <a:prstGeom prst="rect">
            <a:avLst/>
          </a:prstGeom>
        </p:spPr>
      </p:pic>
      <p:sp>
        <p:nvSpPr>
          <p:cNvPr id="22" name="TextBox 58"/>
          <p:cNvSpPr txBox="1"/>
          <p:nvPr/>
        </p:nvSpPr>
        <p:spPr>
          <a:xfrm>
            <a:off x="9126215" y="-6306"/>
            <a:ext cx="3065784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Neighborhood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Miscellanous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23" name="TextBox 57"/>
          <p:cNvSpPr txBox="1"/>
          <p:nvPr/>
        </p:nvSpPr>
        <p:spPr>
          <a:xfrm>
            <a:off x="1777794" y="-24865"/>
            <a:ext cx="1530639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istance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24" name="TextBox 59"/>
          <p:cNvSpPr txBox="1"/>
          <p:nvPr/>
        </p:nvSpPr>
        <p:spPr>
          <a:xfrm>
            <a:off x="5091383" y="-6306"/>
            <a:ext cx="2593075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egree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Eigen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3611" y="3328244"/>
            <a:ext cx="3931744" cy="3529756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 rot="16200000">
            <a:off x="-1208592" y="4908457"/>
            <a:ext cx="284945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Neighborhood_transferred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58161" y="3341123"/>
            <a:ext cx="4072321" cy="351687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43288" y="3341123"/>
            <a:ext cx="3748711" cy="36060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93830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-523672" y="4828434"/>
            <a:ext cx="141667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>
                <a:latin typeface="Adobe Caslon Pro" panose="0205050205050A020403" pitchFamily="18" charset="0"/>
              </a:rPr>
              <a:t>Erdős</a:t>
            </a:r>
            <a:r>
              <a:rPr lang="en-US" dirty="0">
                <a:latin typeface="Adobe Caslon Pro" panose="0205050205050A020403" pitchFamily="18" charset="0"/>
              </a:rPr>
              <a:t>–</a:t>
            </a:r>
            <a:r>
              <a:rPr lang="en-US" dirty="0" err="1">
                <a:latin typeface="Adobe Caslon Pro" panose="0205050205050A020403" pitchFamily="18" charset="0"/>
              </a:rPr>
              <a:t>Rényi</a:t>
            </a:r>
            <a:r>
              <a:rPr lang="en-US" dirty="0" smtClean="0">
                <a:latin typeface="Adobe Caslon Pro" panose="0205050205050A020403" pitchFamily="18" charset="0"/>
              </a:rPr>
              <a:t> </a:t>
            </a:r>
            <a:endParaRPr lang="fa-IR" dirty="0">
              <a:latin typeface="Adobe Caslon Pro" panose="0205050205050A020403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-737951" y="1523563"/>
            <a:ext cx="184523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err="1" smtClean="0">
                <a:latin typeface="Adobe Caslon Pro" panose="0205050205050A020403" pitchFamily="18" charset="0"/>
              </a:rPr>
              <a:t>Combined_score</a:t>
            </a:r>
            <a:endParaRPr lang="fa-IR" dirty="0">
              <a:latin typeface="Adobe Caslon Pro" panose="0205050205050A020403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333" y="3309867"/>
            <a:ext cx="3976024" cy="354813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5358" y="3328335"/>
            <a:ext cx="4085128" cy="352966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485" y="3328335"/>
            <a:ext cx="3761515" cy="352966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30484" y="301471"/>
            <a:ext cx="3761515" cy="3008397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5357" y="326244"/>
            <a:ext cx="4085126" cy="300693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9330" y="326244"/>
            <a:ext cx="3929437" cy="2983623"/>
          </a:xfrm>
          <a:prstGeom prst="rect">
            <a:avLst/>
          </a:prstGeom>
        </p:spPr>
      </p:pic>
      <p:sp>
        <p:nvSpPr>
          <p:cNvPr id="18" name="TextBox 58"/>
          <p:cNvSpPr txBox="1"/>
          <p:nvPr/>
        </p:nvSpPr>
        <p:spPr>
          <a:xfrm>
            <a:off x="9126215" y="-6306"/>
            <a:ext cx="3065784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Neighborhood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Miscellanous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19" name="TextBox 57"/>
          <p:cNvSpPr txBox="1"/>
          <p:nvPr/>
        </p:nvSpPr>
        <p:spPr>
          <a:xfrm>
            <a:off x="1777794" y="-24865"/>
            <a:ext cx="1530639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istance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  <p:sp>
        <p:nvSpPr>
          <p:cNvPr id="20" name="TextBox 59"/>
          <p:cNvSpPr txBox="1"/>
          <p:nvPr/>
        </p:nvSpPr>
        <p:spPr>
          <a:xfrm>
            <a:off x="5091383" y="-6306"/>
            <a:ext cx="2593075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defPPr>
              <a:defRPr lang="fa-I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 err="1" smtClean="0">
                <a:latin typeface="Adobe Caslon Pro" panose="0205050205050A020403" pitchFamily="18" charset="0"/>
              </a:rPr>
              <a:t>Degree_based</a:t>
            </a:r>
            <a:r>
              <a:rPr lang="en-US" sz="1400" dirty="0" smtClean="0">
                <a:latin typeface="Adobe Caslon Pro" panose="0205050205050A020403" pitchFamily="18" charset="0"/>
              </a:rPr>
              <a:t> &amp; </a:t>
            </a:r>
            <a:r>
              <a:rPr lang="en-US" sz="1400" dirty="0" err="1" smtClean="0">
                <a:latin typeface="Adobe Caslon Pro" panose="0205050205050A020403" pitchFamily="18" charset="0"/>
              </a:rPr>
              <a:t>Eigen_based</a:t>
            </a:r>
            <a:endParaRPr lang="fa-IR" sz="1400" dirty="0">
              <a:latin typeface="Adobe Caslon Pro" panose="0205050205050A0204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6124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49</Words>
  <Application>Microsoft Office PowerPoint</Application>
  <PresentationFormat>Widescreen</PresentationFormat>
  <Paragraphs>2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dobe Caslon Pr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ooo</dc:creator>
  <cp:lastModifiedBy>Minooo</cp:lastModifiedBy>
  <cp:revision>15</cp:revision>
  <dcterms:created xsi:type="dcterms:W3CDTF">2016-12-20T21:30:12Z</dcterms:created>
  <dcterms:modified xsi:type="dcterms:W3CDTF">2017-01-01T12:10:24Z</dcterms:modified>
</cp:coreProperties>
</file>